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1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B5E7B-3541-42DC-9E05-2732C8614820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B16DD-43B8-4025-8A65-B07FE2D1CA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5086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B5E7B-3541-42DC-9E05-2732C8614820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B16DD-43B8-4025-8A65-B07FE2D1CA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8563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B5E7B-3541-42DC-9E05-2732C8614820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B16DD-43B8-4025-8A65-B07FE2D1CA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7884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B5E7B-3541-42DC-9E05-2732C8614820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B16DD-43B8-4025-8A65-B07FE2D1CA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3390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B5E7B-3541-42DC-9E05-2732C8614820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B16DD-43B8-4025-8A65-B07FE2D1CA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5224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B5E7B-3541-42DC-9E05-2732C8614820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B16DD-43B8-4025-8A65-B07FE2D1CA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19757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B5E7B-3541-42DC-9E05-2732C8614820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B16DD-43B8-4025-8A65-B07FE2D1CA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8156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B5E7B-3541-42DC-9E05-2732C8614820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B16DD-43B8-4025-8A65-B07FE2D1CA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4432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B5E7B-3541-42DC-9E05-2732C8614820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B16DD-43B8-4025-8A65-B07FE2D1CA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9391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B5E7B-3541-42DC-9E05-2732C8614820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B16DD-43B8-4025-8A65-B07FE2D1CA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3702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B5E7B-3541-42DC-9E05-2732C8614820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B16DD-43B8-4025-8A65-B07FE2D1CA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89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8B5E7B-3541-42DC-9E05-2732C8614820}" type="datetimeFigureOut">
              <a:rPr lang="zh-CN" altLang="en-US" smtClean="0"/>
              <a:t>2023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3B16DD-43B8-4025-8A65-B07FE2D1CA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0402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4C4079DD-0F00-4440-8904-B66BDA8839E2}"/>
              </a:ext>
            </a:extLst>
          </p:cNvPr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78275" y="2639566"/>
            <a:ext cx="4725670" cy="16090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BB99172E-82D0-4194-B0A2-F36606916AB0}"/>
              </a:ext>
            </a:extLst>
          </p:cNvPr>
          <p:cNvSpPr txBox="1"/>
          <p:nvPr/>
        </p:nvSpPr>
        <p:spPr>
          <a:xfrm>
            <a:off x="709864" y="4776539"/>
            <a:ext cx="504123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7.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garose electrophoresis of total RNAs isolated from seed kernels of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meiocarpa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 var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Hongguo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. oleifera cv Min 43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7</a:t>
            </a:r>
            <a:r>
              <a:rPr lang="en-US" altLang="zh-CN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week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Sep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26</a:t>
            </a:r>
            <a:r>
              <a:rPr lang="zh-CN" alt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d the 52</a:t>
            </a:r>
            <a:r>
              <a:rPr lang="en-US" altLang="zh-CN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week (Nov. 1) </a:t>
            </a:r>
            <a:r>
              <a:rPr lang="en-US" altLang="zh-CN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tter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hesis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zh-CN" alt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F36150E4-DD5E-4766-AC89-8E9BFC86E3DD}"/>
              </a:ext>
            </a:extLst>
          </p:cNvPr>
          <p:cNvGrpSpPr/>
          <p:nvPr/>
        </p:nvGrpSpPr>
        <p:grpSpPr>
          <a:xfrm>
            <a:off x="847647" y="2264349"/>
            <a:ext cx="4864055" cy="352101"/>
            <a:chOff x="847647" y="2026355"/>
            <a:chExt cx="4864055" cy="352101"/>
          </a:xfrm>
        </p:grpSpPr>
        <p:cxnSp>
          <p:nvCxnSpPr>
            <p:cNvPr id="5" name="直接连接符 4">
              <a:extLst>
                <a:ext uri="{FF2B5EF4-FFF2-40B4-BE49-F238E27FC236}">
                  <a16:creationId xmlns:a16="http://schemas.microsoft.com/office/drawing/2014/main" id="{CC65A194-E1E2-4F39-9DAD-9C18940DF150}"/>
                </a:ext>
              </a:extLst>
            </p:cNvPr>
            <p:cNvCxnSpPr/>
            <p:nvPr/>
          </p:nvCxnSpPr>
          <p:spPr>
            <a:xfrm>
              <a:off x="962526" y="2354401"/>
              <a:ext cx="93846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接连接符 5">
              <a:extLst>
                <a:ext uri="{FF2B5EF4-FFF2-40B4-BE49-F238E27FC236}">
                  <a16:creationId xmlns:a16="http://schemas.microsoft.com/office/drawing/2014/main" id="{06C14F08-73F1-48F9-8BD8-6372A6C08044}"/>
                </a:ext>
              </a:extLst>
            </p:cNvPr>
            <p:cNvCxnSpPr/>
            <p:nvPr/>
          </p:nvCxnSpPr>
          <p:spPr>
            <a:xfrm>
              <a:off x="2161679" y="2362417"/>
              <a:ext cx="93846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id="{CA1D3C96-586D-491E-A320-2E3FA8884A71}"/>
                </a:ext>
              </a:extLst>
            </p:cNvPr>
            <p:cNvCxnSpPr/>
            <p:nvPr/>
          </p:nvCxnSpPr>
          <p:spPr>
            <a:xfrm>
              <a:off x="3336769" y="2370436"/>
              <a:ext cx="93846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56F4CC5D-B9B8-44F3-A635-3B86CCD6BD98}"/>
                </a:ext>
              </a:extLst>
            </p:cNvPr>
            <p:cNvCxnSpPr/>
            <p:nvPr/>
          </p:nvCxnSpPr>
          <p:spPr>
            <a:xfrm>
              <a:off x="4475763" y="2378456"/>
              <a:ext cx="93846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27BB9B1C-B281-4951-8E5F-90B86C28D199}"/>
                </a:ext>
              </a:extLst>
            </p:cNvPr>
            <p:cNvSpPr txBox="1"/>
            <p:nvPr/>
          </p:nvSpPr>
          <p:spPr>
            <a:xfrm rot="21133390">
              <a:off x="847647" y="2030366"/>
              <a:ext cx="17091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. </a:t>
              </a:r>
              <a:r>
                <a:rPr lang="en-US" altLang="zh-CN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eiocarpa</a:t>
              </a:r>
              <a:r>
                <a:rPr lang="en-US" altLang="zh-CN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 var </a:t>
              </a:r>
              <a:r>
                <a:rPr lang="en-US" altLang="zh-CN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ongguo</a:t>
              </a:r>
              <a:endParaRPr lang="zh-CN" alt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C888DB95-B422-463F-8488-BDC7EC558770}"/>
                </a:ext>
              </a:extLst>
            </p:cNvPr>
            <p:cNvSpPr txBox="1"/>
            <p:nvPr/>
          </p:nvSpPr>
          <p:spPr>
            <a:xfrm rot="21060111">
              <a:off x="3212871" y="2026355"/>
              <a:ext cx="17091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. </a:t>
              </a:r>
              <a:r>
                <a:rPr lang="en-US" altLang="zh-CN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eiocarpa</a:t>
              </a:r>
              <a:r>
                <a:rPr lang="en-US" altLang="zh-CN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 var </a:t>
              </a:r>
              <a:r>
                <a:rPr lang="en-US" altLang="zh-CN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ongguo</a:t>
              </a:r>
              <a:endParaRPr lang="zh-CN" alt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C11A12CC-B496-4E98-9C23-D908BD96368D}"/>
                </a:ext>
              </a:extLst>
            </p:cNvPr>
            <p:cNvSpPr txBox="1"/>
            <p:nvPr/>
          </p:nvSpPr>
          <p:spPr>
            <a:xfrm rot="21212152">
              <a:off x="2056709" y="2072013"/>
              <a:ext cx="13484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. oleifera cv Min 43</a:t>
              </a:r>
              <a:endParaRPr lang="zh-CN" alt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346DDDB9-AF0E-4A30-B63B-6C36AE8D1F94}"/>
                </a:ext>
              </a:extLst>
            </p:cNvPr>
            <p:cNvSpPr txBox="1"/>
            <p:nvPr/>
          </p:nvSpPr>
          <p:spPr>
            <a:xfrm rot="21138424">
              <a:off x="4363256" y="2054483"/>
              <a:ext cx="13484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. oleifera cv Min 43</a:t>
              </a:r>
              <a:endParaRPr lang="zh-CN" alt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27435982-1A75-4F8C-B2E1-7E76623E031D}"/>
              </a:ext>
            </a:extLst>
          </p:cNvPr>
          <p:cNvGrpSpPr/>
          <p:nvPr/>
        </p:nvGrpSpPr>
        <p:grpSpPr>
          <a:xfrm>
            <a:off x="1010651" y="1964881"/>
            <a:ext cx="4476354" cy="289791"/>
            <a:chOff x="1010651" y="1401211"/>
            <a:chExt cx="4476354" cy="289791"/>
          </a:xfrm>
        </p:grpSpPr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id="{9EA7EBFB-8693-4947-A05B-FA4E4099CF9C}"/>
                </a:ext>
              </a:extLst>
            </p:cNvPr>
            <p:cNvCxnSpPr>
              <a:cxnSpLocks/>
            </p:cNvCxnSpPr>
            <p:nvPr/>
          </p:nvCxnSpPr>
          <p:spPr>
            <a:xfrm>
              <a:off x="1010651" y="1664020"/>
              <a:ext cx="217029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接连接符 15">
              <a:extLst>
                <a:ext uri="{FF2B5EF4-FFF2-40B4-BE49-F238E27FC236}">
                  <a16:creationId xmlns:a16="http://schemas.microsoft.com/office/drawing/2014/main" id="{3BEE38DF-A091-4C6C-A59B-651AF431FF49}"/>
                </a:ext>
              </a:extLst>
            </p:cNvPr>
            <p:cNvCxnSpPr>
              <a:cxnSpLocks/>
            </p:cNvCxnSpPr>
            <p:nvPr/>
          </p:nvCxnSpPr>
          <p:spPr>
            <a:xfrm>
              <a:off x="3316706" y="1659510"/>
              <a:ext cx="217029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DC401B42-543F-45CD-86D6-B8CD5B1F1174}"/>
                </a:ext>
              </a:extLst>
            </p:cNvPr>
            <p:cNvSpPr txBox="1"/>
            <p:nvPr/>
          </p:nvSpPr>
          <p:spPr>
            <a:xfrm>
              <a:off x="1275348" y="1444781"/>
              <a:ext cx="13740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eptember 26, 2015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5E94D31C-2275-4FFE-A90E-84B5FC9C2CFE}"/>
                </a:ext>
              </a:extLst>
            </p:cNvPr>
            <p:cNvSpPr txBox="1"/>
            <p:nvPr/>
          </p:nvSpPr>
          <p:spPr>
            <a:xfrm>
              <a:off x="3677660" y="1401211"/>
              <a:ext cx="12682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ovember 1, 2015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68426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</TotalTime>
  <Words>77</Words>
  <Application>Microsoft Office PowerPoint</Application>
  <PresentationFormat>A4 纸张(210x297 毫米)</PresentationFormat>
  <Paragraphs>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user</cp:lastModifiedBy>
  <cp:revision>12</cp:revision>
  <dcterms:created xsi:type="dcterms:W3CDTF">2021-02-20T10:27:38Z</dcterms:created>
  <dcterms:modified xsi:type="dcterms:W3CDTF">2023-06-27T07:37:19Z</dcterms:modified>
</cp:coreProperties>
</file>